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300" r:id="rId2"/>
    <p:sldId id="290" r:id="rId3"/>
    <p:sldId id="298" r:id="rId4"/>
    <p:sldId id="294" r:id="rId5"/>
    <p:sldId id="292" r:id="rId6"/>
    <p:sldId id="299" r:id="rId7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8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673" autoAdjust="0"/>
    <p:restoredTop sz="96366" autoAdjust="0"/>
  </p:normalViewPr>
  <p:slideViewPr>
    <p:cSldViewPr>
      <p:cViewPr varScale="1">
        <p:scale>
          <a:sx n="69" d="100"/>
          <a:sy n="69" d="100"/>
        </p:scale>
        <p:origin x="1968" y="64"/>
      </p:cViewPr>
      <p:guideLst>
        <p:guide orient="horz" pos="3120"/>
        <p:guide pos="21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4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17EF0B-25B6-4A2B-BA66-A79175243B92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214219-E42D-4669-A0E4-5E43DA25025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214219-E42D-4669-A0E4-5E43DA25025C}" type="slidenum">
              <a:rPr lang="zh-CN" altLang="en-US" smtClean="0"/>
              <a:t>5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162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330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49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661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824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992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155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32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4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4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277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1pPr>
            <a:lvl2pPr marL="316230" indent="0">
              <a:buNone/>
              <a:defRPr sz="1245">
                <a:solidFill>
                  <a:schemeClr val="tx1">
                    <a:tint val="75000"/>
                  </a:schemeClr>
                </a:solidFill>
              </a:defRPr>
            </a:lvl2pPr>
            <a:lvl3pPr marL="633095" indent="0">
              <a:buNone/>
              <a:defRPr sz="1110">
                <a:solidFill>
                  <a:schemeClr val="tx1">
                    <a:tint val="75000"/>
                  </a:schemeClr>
                </a:solidFill>
              </a:defRPr>
            </a:lvl3pPr>
            <a:lvl4pPr marL="949325" indent="0">
              <a:buNone/>
              <a:defRPr sz="970">
                <a:solidFill>
                  <a:schemeClr val="tx1">
                    <a:tint val="75000"/>
                  </a:schemeClr>
                </a:solidFill>
              </a:defRPr>
            </a:lvl4pPr>
            <a:lvl5pPr marL="1266190" indent="0">
              <a:buNone/>
              <a:defRPr sz="970">
                <a:solidFill>
                  <a:schemeClr val="tx1">
                    <a:tint val="75000"/>
                  </a:schemeClr>
                </a:solidFill>
              </a:defRPr>
            </a:lvl5pPr>
            <a:lvl6pPr marL="1582420" indent="0">
              <a:buNone/>
              <a:defRPr sz="970">
                <a:solidFill>
                  <a:schemeClr val="tx1">
                    <a:tint val="75000"/>
                  </a:schemeClr>
                </a:solidFill>
              </a:defRPr>
            </a:lvl6pPr>
            <a:lvl7pPr marL="1899285" indent="0">
              <a:buNone/>
              <a:defRPr sz="970">
                <a:solidFill>
                  <a:schemeClr val="tx1">
                    <a:tint val="75000"/>
                  </a:schemeClr>
                </a:solidFill>
              </a:defRPr>
            </a:lvl7pPr>
            <a:lvl8pPr marL="2215515" indent="0">
              <a:buNone/>
              <a:defRPr sz="970">
                <a:solidFill>
                  <a:schemeClr val="tx1">
                    <a:tint val="75000"/>
                  </a:schemeClr>
                </a:solidFill>
              </a:defRPr>
            </a:lvl8pPr>
            <a:lvl9pPr marL="2532380" indent="0">
              <a:buNone/>
              <a:defRPr sz="9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1940"/>
            </a:lvl1pPr>
            <a:lvl2pPr>
              <a:defRPr sz="1660"/>
            </a:lvl2pPr>
            <a:lvl3pPr>
              <a:defRPr sz="1385"/>
            </a:lvl3pPr>
            <a:lvl4pPr>
              <a:defRPr sz="1245"/>
            </a:lvl4pPr>
            <a:lvl5pPr>
              <a:defRPr sz="1245"/>
            </a:lvl5pPr>
            <a:lvl6pPr>
              <a:defRPr sz="1245"/>
            </a:lvl6pPr>
            <a:lvl7pPr>
              <a:defRPr sz="1245"/>
            </a:lvl7pPr>
            <a:lvl8pPr>
              <a:defRPr sz="1245"/>
            </a:lvl8pPr>
            <a:lvl9pPr>
              <a:defRPr sz="124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1940"/>
            </a:lvl1pPr>
            <a:lvl2pPr>
              <a:defRPr sz="1660"/>
            </a:lvl2pPr>
            <a:lvl3pPr>
              <a:defRPr sz="1385"/>
            </a:lvl3pPr>
            <a:lvl4pPr>
              <a:defRPr sz="1245"/>
            </a:lvl4pPr>
            <a:lvl5pPr>
              <a:defRPr sz="1245"/>
            </a:lvl5pPr>
            <a:lvl6pPr>
              <a:defRPr sz="1245"/>
            </a:lvl6pPr>
            <a:lvl7pPr>
              <a:defRPr sz="1245"/>
            </a:lvl7pPr>
            <a:lvl8pPr>
              <a:defRPr sz="1245"/>
            </a:lvl8pPr>
            <a:lvl9pPr>
              <a:defRPr sz="124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1660" b="1"/>
            </a:lvl1pPr>
            <a:lvl2pPr marL="316230" indent="0">
              <a:buNone/>
              <a:defRPr sz="1385" b="1"/>
            </a:lvl2pPr>
            <a:lvl3pPr marL="633095" indent="0">
              <a:buNone/>
              <a:defRPr sz="1245" b="1"/>
            </a:lvl3pPr>
            <a:lvl4pPr marL="949325" indent="0">
              <a:buNone/>
              <a:defRPr sz="1110" b="1"/>
            </a:lvl4pPr>
            <a:lvl5pPr marL="1266190" indent="0">
              <a:buNone/>
              <a:defRPr sz="1110" b="1"/>
            </a:lvl5pPr>
            <a:lvl6pPr marL="1582420" indent="0">
              <a:buNone/>
              <a:defRPr sz="1110" b="1"/>
            </a:lvl6pPr>
            <a:lvl7pPr marL="1899285" indent="0">
              <a:buNone/>
              <a:defRPr sz="1110" b="1"/>
            </a:lvl7pPr>
            <a:lvl8pPr marL="2215515" indent="0">
              <a:buNone/>
              <a:defRPr sz="1110" b="1"/>
            </a:lvl8pPr>
            <a:lvl9pPr marL="2532380" indent="0">
              <a:buNone/>
              <a:defRPr sz="111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1660"/>
            </a:lvl1pPr>
            <a:lvl2pPr>
              <a:defRPr sz="1385"/>
            </a:lvl2pPr>
            <a:lvl3pPr>
              <a:defRPr sz="1245"/>
            </a:lvl3pPr>
            <a:lvl4pPr>
              <a:defRPr sz="1110"/>
            </a:lvl4pPr>
            <a:lvl5pPr>
              <a:defRPr sz="1110"/>
            </a:lvl5pPr>
            <a:lvl6pPr>
              <a:defRPr sz="1110"/>
            </a:lvl6pPr>
            <a:lvl7pPr>
              <a:defRPr sz="1110"/>
            </a:lvl7pPr>
            <a:lvl8pPr>
              <a:defRPr sz="1110"/>
            </a:lvl8pPr>
            <a:lvl9pPr>
              <a:defRPr sz="111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1660" b="1"/>
            </a:lvl1pPr>
            <a:lvl2pPr marL="316230" indent="0">
              <a:buNone/>
              <a:defRPr sz="1385" b="1"/>
            </a:lvl2pPr>
            <a:lvl3pPr marL="633095" indent="0">
              <a:buNone/>
              <a:defRPr sz="1245" b="1"/>
            </a:lvl3pPr>
            <a:lvl4pPr marL="949325" indent="0">
              <a:buNone/>
              <a:defRPr sz="1110" b="1"/>
            </a:lvl4pPr>
            <a:lvl5pPr marL="1266190" indent="0">
              <a:buNone/>
              <a:defRPr sz="1110" b="1"/>
            </a:lvl5pPr>
            <a:lvl6pPr marL="1582420" indent="0">
              <a:buNone/>
              <a:defRPr sz="1110" b="1"/>
            </a:lvl6pPr>
            <a:lvl7pPr marL="1899285" indent="0">
              <a:buNone/>
              <a:defRPr sz="1110" b="1"/>
            </a:lvl7pPr>
            <a:lvl8pPr marL="2215515" indent="0">
              <a:buNone/>
              <a:defRPr sz="1110" b="1"/>
            </a:lvl8pPr>
            <a:lvl9pPr marL="2532380" indent="0">
              <a:buNone/>
              <a:defRPr sz="111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1660"/>
            </a:lvl1pPr>
            <a:lvl2pPr>
              <a:defRPr sz="1385"/>
            </a:lvl2pPr>
            <a:lvl3pPr>
              <a:defRPr sz="1245"/>
            </a:lvl3pPr>
            <a:lvl4pPr>
              <a:defRPr sz="1110"/>
            </a:lvl4pPr>
            <a:lvl5pPr>
              <a:defRPr sz="1110"/>
            </a:lvl5pPr>
            <a:lvl6pPr>
              <a:defRPr sz="1110"/>
            </a:lvl6pPr>
            <a:lvl7pPr>
              <a:defRPr sz="1110"/>
            </a:lvl7pPr>
            <a:lvl8pPr>
              <a:defRPr sz="1110"/>
            </a:lvl8pPr>
            <a:lvl9pPr>
              <a:defRPr sz="111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2215"/>
            </a:lvl1pPr>
            <a:lvl2pPr>
              <a:defRPr sz="1940"/>
            </a:lvl2pPr>
            <a:lvl3pPr>
              <a:defRPr sz="1660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970"/>
            </a:lvl1pPr>
            <a:lvl2pPr marL="316230" indent="0">
              <a:buNone/>
              <a:defRPr sz="830"/>
            </a:lvl2pPr>
            <a:lvl3pPr marL="633095" indent="0">
              <a:buNone/>
              <a:defRPr sz="690"/>
            </a:lvl3pPr>
            <a:lvl4pPr marL="949325" indent="0">
              <a:buNone/>
              <a:defRPr sz="625"/>
            </a:lvl4pPr>
            <a:lvl5pPr marL="1266190" indent="0">
              <a:buNone/>
              <a:defRPr sz="625"/>
            </a:lvl5pPr>
            <a:lvl6pPr marL="1582420" indent="0">
              <a:buNone/>
              <a:defRPr sz="625"/>
            </a:lvl6pPr>
            <a:lvl7pPr marL="1899285" indent="0">
              <a:buNone/>
              <a:defRPr sz="625"/>
            </a:lvl7pPr>
            <a:lvl8pPr marL="2215515" indent="0">
              <a:buNone/>
              <a:defRPr sz="625"/>
            </a:lvl8pPr>
            <a:lvl9pPr marL="2532380" indent="0">
              <a:buNone/>
              <a:defRPr sz="6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215"/>
            </a:lvl1pPr>
            <a:lvl2pPr marL="316230" indent="0">
              <a:buNone/>
              <a:defRPr sz="1940"/>
            </a:lvl2pPr>
            <a:lvl3pPr marL="633095" indent="0">
              <a:buNone/>
              <a:defRPr sz="1660"/>
            </a:lvl3pPr>
            <a:lvl4pPr marL="949325" indent="0">
              <a:buNone/>
              <a:defRPr sz="1385"/>
            </a:lvl4pPr>
            <a:lvl5pPr marL="1266190" indent="0">
              <a:buNone/>
              <a:defRPr sz="1385"/>
            </a:lvl5pPr>
            <a:lvl6pPr marL="1582420" indent="0">
              <a:buNone/>
              <a:defRPr sz="1385"/>
            </a:lvl6pPr>
            <a:lvl7pPr marL="1899285" indent="0">
              <a:buNone/>
              <a:defRPr sz="1385"/>
            </a:lvl7pPr>
            <a:lvl8pPr marL="2215515" indent="0">
              <a:buNone/>
              <a:defRPr sz="1385"/>
            </a:lvl8pPr>
            <a:lvl9pPr marL="2532380" indent="0">
              <a:buNone/>
              <a:defRPr sz="138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970"/>
            </a:lvl1pPr>
            <a:lvl2pPr marL="316230" indent="0">
              <a:buNone/>
              <a:defRPr sz="830"/>
            </a:lvl2pPr>
            <a:lvl3pPr marL="633095" indent="0">
              <a:buNone/>
              <a:defRPr sz="690"/>
            </a:lvl3pPr>
            <a:lvl4pPr marL="949325" indent="0">
              <a:buNone/>
              <a:defRPr sz="625"/>
            </a:lvl4pPr>
            <a:lvl5pPr marL="1266190" indent="0">
              <a:buNone/>
              <a:defRPr sz="625"/>
            </a:lvl5pPr>
            <a:lvl6pPr marL="1582420" indent="0">
              <a:buNone/>
              <a:defRPr sz="625"/>
            </a:lvl6pPr>
            <a:lvl7pPr marL="1899285" indent="0">
              <a:buNone/>
              <a:defRPr sz="625"/>
            </a:lvl7pPr>
            <a:lvl8pPr marL="2215515" indent="0">
              <a:buNone/>
              <a:defRPr sz="625"/>
            </a:lvl8pPr>
            <a:lvl9pPr marL="2532380" indent="0">
              <a:buNone/>
              <a:defRPr sz="6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-10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9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33095" rtl="0" eaLnBrk="1" latinLnBrk="0" hangingPunct="1">
        <a:spcBef>
          <a:spcPct val="0"/>
        </a:spcBef>
        <a:buNone/>
        <a:defRPr sz="30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7490" indent="-237490" algn="l" defTabSz="6330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215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98120" algn="l" defTabSz="633095" rtl="0" eaLnBrk="1" latinLnBrk="0" hangingPunct="1">
        <a:spcBef>
          <a:spcPct val="20000"/>
        </a:spcBef>
        <a:buFont typeface="Arial" panose="020B0604020202020204" pitchFamily="34" charset="0"/>
        <a:buChar char="–"/>
        <a:defRPr sz="1940" kern="1200">
          <a:solidFill>
            <a:schemeClr val="tx1"/>
          </a:solidFill>
          <a:latin typeface="+mn-lt"/>
          <a:ea typeface="+mn-ea"/>
          <a:cs typeface="+mn-cs"/>
        </a:defRPr>
      </a:lvl2pPr>
      <a:lvl3pPr marL="791210" indent="-158115" algn="l" defTabSz="633095" rtl="0" eaLnBrk="1" latinLnBrk="0" hangingPunct="1">
        <a:spcBef>
          <a:spcPct val="20000"/>
        </a:spcBef>
        <a:buFont typeface="Arial" panose="020B0604020202020204" pitchFamily="34" charset="0"/>
        <a:buChar char="•"/>
        <a:defRPr sz="1660" kern="1200">
          <a:solidFill>
            <a:schemeClr val="tx1"/>
          </a:solidFill>
          <a:latin typeface="+mn-lt"/>
          <a:ea typeface="+mn-ea"/>
          <a:cs typeface="+mn-cs"/>
        </a:defRPr>
      </a:lvl3pPr>
      <a:lvl4pPr marL="1108075" indent="-158115" algn="l" defTabSz="633095" rtl="0" eaLnBrk="1" latinLnBrk="0" hangingPunct="1">
        <a:spcBef>
          <a:spcPct val="20000"/>
        </a:spcBef>
        <a:buFont typeface="Arial" panose="020B0604020202020204" pitchFamily="34" charset="0"/>
        <a:buChar char="–"/>
        <a:defRPr sz="1385" kern="1200">
          <a:solidFill>
            <a:schemeClr val="tx1"/>
          </a:solidFill>
          <a:latin typeface="+mn-lt"/>
          <a:ea typeface="+mn-ea"/>
          <a:cs typeface="+mn-cs"/>
        </a:defRPr>
      </a:lvl4pPr>
      <a:lvl5pPr marL="1424305" indent="-158115" algn="l" defTabSz="633095" rtl="0" eaLnBrk="1" latinLnBrk="0" hangingPunct="1">
        <a:spcBef>
          <a:spcPct val="20000"/>
        </a:spcBef>
        <a:buFont typeface="Arial" panose="020B0604020202020204" pitchFamily="34" charset="0"/>
        <a:buChar char="»"/>
        <a:defRPr sz="1385" kern="1200">
          <a:solidFill>
            <a:schemeClr val="tx1"/>
          </a:solidFill>
          <a:latin typeface="+mn-lt"/>
          <a:ea typeface="+mn-ea"/>
          <a:cs typeface="+mn-cs"/>
        </a:defRPr>
      </a:lvl5pPr>
      <a:lvl6pPr marL="1741170" indent="-158115" algn="l" defTabSz="633095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indent="-158115" algn="l" defTabSz="633095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7pPr>
      <a:lvl8pPr marL="2373630" indent="-158115" algn="l" defTabSz="633095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8pPr>
      <a:lvl9pPr marL="2690495" indent="-158115" algn="l" defTabSz="633095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33095" rtl="0" eaLnBrk="1" latinLnBrk="0" hangingPunct="1">
        <a:defRPr sz="1245" kern="1200">
          <a:solidFill>
            <a:schemeClr val="tx1"/>
          </a:solidFill>
          <a:latin typeface="+mn-lt"/>
          <a:ea typeface="+mn-ea"/>
          <a:cs typeface="+mn-cs"/>
        </a:defRPr>
      </a:lvl1pPr>
      <a:lvl2pPr marL="316230" algn="l" defTabSz="633095" rtl="0" eaLnBrk="1" latinLnBrk="0" hangingPunct="1">
        <a:defRPr sz="1245" kern="1200">
          <a:solidFill>
            <a:schemeClr val="tx1"/>
          </a:solidFill>
          <a:latin typeface="+mn-lt"/>
          <a:ea typeface="+mn-ea"/>
          <a:cs typeface="+mn-cs"/>
        </a:defRPr>
      </a:lvl2pPr>
      <a:lvl3pPr marL="633095" algn="l" defTabSz="633095" rtl="0" eaLnBrk="1" latinLnBrk="0" hangingPunct="1">
        <a:defRPr sz="1245" kern="1200">
          <a:solidFill>
            <a:schemeClr val="tx1"/>
          </a:solidFill>
          <a:latin typeface="+mn-lt"/>
          <a:ea typeface="+mn-ea"/>
          <a:cs typeface="+mn-cs"/>
        </a:defRPr>
      </a:lvl3pPr>
      <a:lvl4pPr marL="949325" algn="l" defTabSz="633095" rtl="0" eaLnBrk="1" latinLnBrk="0" hangingPunct="1">
        <a:defRPr sz="1245" kern="1200">
          <a:solidFill>
            <a:schemeClr val="tx1"/>
          </a:solidFill>
          <a:latin typeface="+mn-lt"/>
          <a:ea typeface="+mn-ea"/>
          <a:cs typeface="+mn-cs"/>
        </a:defRPr>
      </a:lvl4pPr>
      <a:lvl5pPr marL="1266190" algn="l" defTabSz="633095" rtl="0" eaLnBrk="1" latinLnBrk="0" hangingPunct="1">
        <a:defRPr sz="1245" kern="1200">
          <a:solidFill>
            <a:schemeClr val="tx1"/>
          </a:solidFill>
          <a:latin typeface="+mn-lt"/>
          <a:ea typeface="+mn-ea"/>
          <a:cs typeface="+mn-cs"/>
        </a:defRPr>
      </a:lvl5pPr>
      <a:lvl6pPr marL="1582420" algn="l" defTabSz="633095" rtl="0" eaLnBrk="1" latinLnBrk="0" hangingPunct="1">
        <a:defRPr sz="1245" kern="1200">
          <a:solidFill>
            <a:schemeClr val="tx1"/>
          </a:solidFill>
          <a:latin typeface="+mn-lt"/>
          <a:ea typeface="+mn-ea"/>
          <a:cs typeface="+mn-cs"/>
        </a:defRPr>
      </a:lvl6pPr>
      <a:lvl7pPr marL="1899285" algn="l" defTabSz="633095" rtl="0" eaLnBrk="1" latinLnBrk="0" hangingPunct="1">
        <a:defRPr sz="1245" kern="1200">
          <a:solidFill>
            <a:schemeClr val="tx1"/>
          </a:solidFill>
          <a:latin typeface="+mn-lt"/>
          <a:ea typeface="+mn-ea"/>
          <a:cs typeface="+mn-cs"/>
        </a:defRPr>
      </a:lvl7pPr>
      <a:lvl8pPr marL="2215515" algn="l" defTabSz="633095" rtl="0" eaLnBrk="1" latinLnBrk="0" hangingPunct="1">
        <a:defRPr sz="1245" kern="1200">
          <a:solidFill>
            <a:schemeClr val="tx1"/>
          </a:solidFill>
          <a:latin typeface="+mn-lt"/>
          <a:ea typeface="+mn-ea"/>
          <a:cs typeface="+mn-cs"/>
        </a:defRPr>
      </a:lvl8pPr>
      <a:lvl9pPr marL="2532380" algn="l" defTabSz="633095" rtl="0" eaLnBrk="1" latinLnBrk="0" hangingPunct="1">
        <a:defRPr sz="12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332656" y="1352600"/>
            <a:ext cx="6192688" cy="3343999"/>
          </a:xfrm>
        </p:spPr>
        <p:txBody>
          <a:bodyPr>
            <a:norm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2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logeneic Vγ9Vδ2 T Cell Therapy Promote Pulmonary Lesion Repairment: </a:t>
            </a:r>
            <a:r>
              <a:rPr lang="en-US" sz="24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 Open-labelled, Single-arm</a:t>
            </a:r>
            <a:r>
              <a:rPr lang="en-US" sz="2400" b="1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Pilot </a:t>
            </a:r>
            <a:r>
              <a:rPr lang="en-US" sz="24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udy in MDR-TB Patients</a:t>
            </a:r>
            <a:endParaRPr lang="zh-CN" altLang="zh-CN" sz="2400" b="1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altLang="zh-CN" sz="44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J</a:t>
            </a:r>
            <a:r>
              <a:rPr lang="en-US" altLang="zh-CN" sz="4400" dirty="0"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r>
              <a:rPr lang="zh-CN" altLang="en-US" sz="4400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44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iang et al.</a:t>
            </a:r>
            <a:endParaRPr lang="zh-CN" altLang="en-US" sz="48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911323" y="3584848"/>
            <a:ext cx="503535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s</a:t>
            </a:r>
            <a:endParaRPr lang="zh-CN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46158" y="325324"/>
            <a:ext cx="325762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32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1 </a:t>
            </a:r>
            <a:endParaRPr lang="zh-CN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右箭头 2"/>
          <p:cNvSpPr/>
          <p:nvPr/>
        </p:nvSpPr>
        <p:spPr>
          <a:xfrm>
            <a:off x="1274114" y="2415141"/>
            <a:ext cx="4874346" cy="423282"/>
          </a:xfrm>
          <a:prstGeom prst="rightArrow">
            <a:avLst/>
          </a:prstGeom>
          <a:solidFill>
            <a:srgbClr val="93E3FF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" name="TextBox 2"/>
          <p:cNvSpPr txBox="1"/>
          <p:nvPr/>
        </p:nvSpPr>
        <p:spPr>
          <a:xfrm>
            <a:off x="1373413" y="2508973"/>
            <a:ext cx="430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W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3"/>
          <p:cNvSpPr txBox="1"/>
          <p:nvPr/>
        </p:nvSpPr>
        <p:spPr>
          <a:xfrm>
            <a:off x="2301432" y="2509497"/>
            <a:ext cx="4702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W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4"/>
          <p:cNvSpPr txBox="1"/>
          <p:nvPr/>
        </p:nvSpPr>
        <p:spPr>
          <a:xfrm>
            <a:off x="3339234" y="2523993"/>
            <a:ext cx="430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W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5"/>
          <p:cNvSpPr txBox="1"/>
          <p:nvPr/>
        </p:nvSpPr>
        <p:spPr>
          <a:xfrm>
            <a:off x="4434197" y="2523993"/>
            <a:ext cx="4702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 W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6"/>
          <p:cNvSpPr txBox="1"/>
          <p:nvPr/>
        </p:nvSpPr>
        <p:spPr>
          <a:xfrm>
            <a:off x="1646147" y="1623621"/>
            <a:ext cx="3819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1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7"/>
          <p:cNvSpPr txBox="1"/>
          <p:nvPr/>
        </p:nvSpPr>
        <p:spPr>
          <a:xfrm>
            <a:off x="2515032" y="1638211"/>
            <a:ext cx="339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2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8"/>
          <p:cNvSpPr txBox="1"/>
          <p:nvPr/>
        </p:nvSpPr>
        <p:spPr>
          <a:xfrm>
            <a:off x="3573039" y="1675101"/>
            <a:ext cx="3819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3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9"/>
          <p:cNvSpPr txBox="1"/>
          <p:nvPr/>
        </p:nvSpPr>
        <p:spPr>
          <a:xfrm>
            <a:off x="4649050" y="1694151"/>
            <a:ext cx="339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4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下箭头 11"/>
          <p:cNvSpPr/>
          <p:nvPr/>
        </p:nvSpPr>
        <p:spPr>
          <a:xfrm>
            <a:off x="1706160" y="1958136"/>
            <a:ext cx="170876" cy="527542"/>
          </a:xfrm>
          <a:prstGeom prst="downArrow">
            <a:avLst/>
          </a:prstGeom>
          <a:solidFill>
            <a:schemeClr val="bg1"/>
          </a:solidFill>
          <a:ln>
            <a:solidFill>
              <a:srgbClr val="FF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13" name="下箭头 12"/>
          <p:cNvSpPr/>
          <p:nvPr/>
        </p:nvSpPr>
        <p:spPr>
          <a:xfrm>
            <a:off x="2597270" y="1948615"/>
            <a:ext cx="170876" cy="527542"/>
          </a:xfrm>
          <a:prstGeom prst="downArrow">
            <a:avLst/>
          </a:prstGeom>
          <a:solidFill>
            <a:schemeClr val="bg1"/>
          </a:solidFill>
          <a:ln>
            <a:solidFill>
              <a:srgbClr val="FF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14" name="下箭头 13"/>
          <p:cNvSpPr/>
          <p:nvPr/>
        </p:nvSpPr>
        <p:spPr>
          <a:xfrm>
            <a:off x="3645882" y="1973413"/>
            <a:ext cx="170876" cy="527542"/>
          </a:xfrm>
          <a:prstGeom prst="downArrow">
            <a:avLst/>
          </a:prstGeom>
          <a:solidFill>
            <a:schemeClr val="bg1"/>
          </a:solidFill>
          <a:ln>
            <a:solidFill>
              <a:srgbClr val="FF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15" name="下箭头 14"/>
          <p:cNvSpPr/>
          <p:nvPr/>
        </p:nvSpPr>
        <p:spPr>
          <a:xfrm>
            <a:off x="4721763" y="1977186"/>
            <a:ext cx="170876" cy="527542"/>
          </a:xfrm>
          <a:prstGeom prst="downArrow">
            <a:avLst/>
          </a:prstGeom>
          <a:solidFill>
            <a:schemeClr val="bg1"/>
          </a:solidFill>
          <a:ln>
            <a:solidFill>
              <a:srgbClr val="FF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16" name="下箭头 15"/>
          <p:cNvSpPr/>
          <p:nvPr/>
        </p:nvSpPr>
        <p:spPr>
          <a:xfrm rot="10800000">
            <a:off x="1300110" y="2787243"/>
            <a:ext cx="177440" cy="539308"/>
          </a:xfrm>
          <a:prstGeom prst="downArrow">
            <a:avLst/>
          </a:prstGeom>
          <a:solidFill>
            <a:schemeClr val="bg1"/>
          </a:solidFill>
          <a:ln>
            <a:solidFill>
              <a:srgbClr val="03ED0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17" name="下箭头 16"/>
          <p:cNvSpPr/>
          <p:nvPr/>
        </p:nvSpPr>
        <p:spPr>
          <a:xfrm rot="10800000">
            <a:off x="2286594" y="2779296"/>
            <a:ext cx="177440" cy="539308"/>
          </a:xfrm>
          <a:prstGeom prst="downArrow">
            <a:avLst/>
          </a:prstGeom>
          <a:solidFill>
            <a:schemeClr val="bg1"/>
          </a:solidFill>
          <a:ln>
            <a:solidFill>
              <a:srgbClr val="03ED0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18" name="下箭头 17"/>
          <p:cNvSpPr/>
          <p:nvPr/>
        </p:nvSpPr>
        <p:spPr>
          <a:xfrm rot="10800000">
            <a:off x="3291577" y="2787243"/>
            <a:ext cx="177440" cy="539308"/>
          </a:xfrm>
          <a:prstGeom prst="downArrow">
            <a:avLst/>
          </a:prstGeom>
          <a:solidFill>
            <a:schemeClr val="bg1"/>
          </a:solidFill>
          <a:ln>
            <a:solidFill>
              <a:srgbClr val="03ED0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19" name="下箭头 18"/>
          <p:cNvSpPr/>
          <p:nvPr/>
        </p:nvSpPr>
        <p:spPr>
          <a:xfrm rot="10800000">
            <a:off x="4384291" y="2787243"/>
            <a:ext cx="177440" cy="539308"/>
          </a:xfrm>
          <a:prstGeom prst="downArrow">
            <a:avLst/>
          </a:prstGeom>
          <a:solidFill>
            <a:schemeClr val="bg1"/>
          </a:solidFill>
          <a:ln>
            <a:solidFill>
              <a:srgbClr val="03ED0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20" name="矩形 19"/>
          <p:cNvSpPr/>
          <p:nvPr/>
        </p:nvSpPr>
        <p:spPr>
          <a:xfrm>
            <a:off x="-27384" y="1885231"/>
            <a:ext cx="121609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δT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 infusion </a:t>
            </a:r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.v.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116632" y="2396417"/>
            <a:ext cx="105027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</a:t>
            </a:r>
          </a:p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stere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3"/>
          <p:cNvSpPr txBox="1"/>
          <p:nvPr/>
        </p:nvSpPr>
        <p:spPr>
          <a:xfrm>
            <a:off x="5581104" y="2509497"/>
            <a:ext cx="5673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W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下箭头 22"/>
          <p:cNvSpPr/>
          <p:nvPr/>
        </p:nvSpPr>
        <p:spPr>
          <a:xfrm rot="10800000">
            <a:off x="5573992" y="2804214"/>
            <a:ext cx="177440" cy="539308"/>
          </a:xfrm>
          <a:prstGeom prst="downArrow">
            <a:avLst/>
          </a:prstGeom>
          <a:solidFill>
            <a:schemeClr val="bg1"/>
          </a:solidFill>
          <a:ln>
            <a:solidFill>
              <a:srgbClr val="03ED0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24" name="TextBox 25"/>
          <p:cNvSpPr txBox="1"/>
          <p:nvPr/>
        </p:nvSpPr>
        <p:spPr>
          <a:xfrm>
            <a:off x="1230679" y="3355353"/>
            <a:ext cx="4044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1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6"/>
          <p:cNvSpPr txBox="1"/>
          <p:nvPr/>
        </p:nvSpPr>
        <p:spPr>
          <a:xfrm>
            <a:off x="2231541" y="3348030"/>
            <a:ext cx="360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2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7"/>
          <p:cNvSpPr txBox="1"/>
          <p:nvPr/>
        </p:nvSpPr>
        <p:spPr>
          <a:xfrm>
            <a:off x="3237514" y="3349506"/>
            <a:ext cx="4044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3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8"/>
          <p:cNvSpPr txBox="1"/>
          <p:nvPr/>
        </p:nvSpPr>
        <p:spPr>
          <a:xfrm>
            <a:off x="4329513" y="3357146"/>
            <a:ext cx="360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4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9"/>
          <p:cNvSpPr txBox="1"/>
          <p:nvPr/>
        </p:nvSpPr>
        <p:spPr>
          <a:xfrm>
            <a:off x="5522584" y="3349455"/>
            <a:ext cx="360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5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30"/>
          <p:cNvSpPr txBox="1"/>
          <p:nvPr/>
        </p:nvSpPr>
        <p:spPr>
          <a:xfrm>
            <a:off x="107479" y="1337217"/>
            <a:ext cx="5260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149012" y="2907604"/>
            <a:ext cx="105596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12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boratory examination</a:t>
            </a:r>
            <a:endParaRPr lang="zh-CN" altLang="en-US" sz="1200" b="1" dirty="0">
              <a:solidFill>
                <a:srgbClr val="008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2769188" y="6011265"/>
            <a:ext cx="4683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 rot="16200000">
            <a:off x="99853" y="5045627"/>
            <a:ext cx="4427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/>
          <p:cNvPicPr>
            <a:picLocks noChangeAspect="1"/>
          </p:cNvPicPr>
          <p:nvPr/>
        </p:nvPicPr>
        <p:blipFill>
          <a:blip r:embed="rId2"/>
          <a:srcRect t="9707"/>
          <a:stretch>
            <a:fillRect/>
          </a:stretch>
        </p:blipFill>
        <p:spPr>
          <a:xfrm>
            <a:off x="536531" y="4528753"/>
            <a:ext cx="1519712" cy="1526679"/>
          </a:xfrm>
          <a:prstGeom prst="rect">
            <a:avLst/>
          </a:prstGeom>
        </p:spPr>
      </p:pic>
      <p:sp>
        <p:nvSpPr>
          <p:cNvPr id="37" name="文本框 36"/>
          <p:cNvSpPr txBox="1"/>
          <p:nvPr/>
        </p:nvSpPr>
        <p:spPr>
          <a:xfrm flipH="1">
            <a:off x="819562" y="4187334"/>
            <a:ext cx="8336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urse 1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 flipH="1">
            <a:off x="2352369" y="4199026"/>
            <a:ext cx="8336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urse 2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 flipH="1">
            <a:off x="3794590" y="4201495"/>
            <a:ext cx="8336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urse 3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 flipH="1">
            <a:off x="5283598" y="4196585"/>
            <a:ext cx="8336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urse 4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2"/>
          <p:cNvPicPr>
            <a:picLocks noChangeAspect="1" noChangeArrowheads="1"/>
          </p:cNvPicPr>
          <p:nvPr/>
        </p:nvPicPr>
        <p:blipFill>
          <a:blip r:embed="rId3"/>
          <a:srcRect t="8855"/>
          <a:stretch>
            <a:fillRect/>
          </a:stretch>
        </p:blipFill>
        <p:spPr bwMode="auto">
          <a:xfrm>
            <a:off x="519757" y="6250705"/>
            <a:ext cx="1529502" cy="15510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2" name="Picture 3"/>
          <p:cNvPicPr>
            <a:picLocks noChangeAspect="1" noChangeArrowheads="1"/>
          </p:cNvPicPr>
          <p:nvPr/>
        </p:nvPicPr>
        <p:blipFill>
          <a:blip r:embed="rId4"/>
          <a:srcRect t="9281"/>
          <a:stretch>
            <a:fillRect/>
          </a:stretch>
        </p:blipFill>
        <p:spPr bwMode="auto">
          <a:xfrm>
            <a:off x="1972215" y="6271465"/>
            <a:ext cx="1529502" cy="15437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3" name="Picture 4"/>
          <p:cNvPicPr>
            <a:picLocks noChangeAspect="1" noChangeArrowheads="1"/>
          </p:cNvPicPr>
          <p:nvPr/>
        </p:nvPicPr>
        <p:blipFill>
          <a:blip r:embed="rId5"/>
          <a:srcRect t="8855"/>
          <a:stretch>
            <a:fillRect/>
          </a:stretch>
        </p:blipFill>
        <p:spPr bwMode="auto">
          <a:xfrm>
            <a:off x="3445010" y="6274700"/>
            <a:ext cx="1529502" cy="15510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4" name="Picture 5"/>
          <p:cNvPicPr>
            <a:picLocks noChangeAspect="1" noChangeArrowheads="1"/>
          </p:cNvPicPr>
          <p:nvPr/>
        </p:nvPicPr>
        <p:blipFill>
          <a:blip r:embed="rId6"/>
          <a:srcRect t="9708"/>
          <a:stretch>
            <a:fillRect/>
          </a:stretch>
        </p:blipFill>
        <p:spPr bwMode="auto">
          <a:xfrm>
            <a:off x="4886104" y="6288342"/>
            <a:ext cx="1529501" cy="15364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7" name="TextBox 33"/>
          <p:cNvSpPr txBox="1"/>
          <p:nvPr/>
        </p:nvSpPr>
        <p:spPr>
          <a:xfrm>
            <a:off x="2611743" y="7744410"/>
            <a:ext cx="8675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nexin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-v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14"/>
          <p:cNvSpPr txBox="1"/>
          <p:nvPr/>
        </p:nvSpPr>
        <p:spPr>
          <a:xfrm rot="16200000">
            <a:off x="151062" y="6751569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1"/>
          <p:cNvSpPr txBox="1"/>
          <p:nvPr/>
        </p:nvSpPr>
        <p:spPr>
          <a:xfrm>
            <a:off x="116632" y="4160912"/>
            <a:ext cx="3138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0" name="Picture 5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1992846" y="4488158"/>
            <a:ext cx="1402493" cy="14024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" name="Picture 6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3429114" y="4501417"/>
            <a:ext cx="1404141" cy="14041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59" name="直接箭头连接符 58"/>
          <p:cNvCxnSpPr/>
          <p:nvPr/>
        </p:nvCxnSpPr>
        <p:spPr>
          <a:xfrm>
            <a:off x="474986" y="6016218"/>
            <a:ext cx="5910123" cy="169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箭头连接符 62"/>
          <p:cNvCxnSpPr/>
          <p:nvPr/>
        </p:nvCxnSpPr>
        <p:spPr>
          <a:xfrm flipV="1">
            <a:off x="474986" y="4448944"/>
            <a:ext cx="0" cy="1567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箭头连接符 65"/>
          <p:cNvCxnSpPr/>
          <p:nvPr/>
        </p:nvCxnSpPr>
        <p:spPr>
          <a:xfrm>
            <a:off x="471205" y="7744410"/>
            <a:ext cx="5910123" cy="169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箭头连接符 66"/>
          <p:cNvCxnSpPr/>
          <p:nvPr/>
        </p:nvCxnSpPr>
        <p:spPr>
          <a:xfrm flipV="1">
            <a:off x="471205" y="6177136"/>
            <a:ext cx="0" cy="1567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9" name="图片 68"/>
          <p:cNvPicPr>
            <a:picLocks noChangeAspect="1"/>
          </p:cNvPicPr>
          <p:nvPr/>
        </p:nvPicPr>
        <p:blipFill rotWithShape="1">
          <a:blip r:embed="rId9"/>
          <a:srcRect l="2503" t="9000" r="7379" b="7751"/>
          <a:stretch>
            <a:fillRect/>
          </a:stretch>
        </p:blipFill>
        <p:spPr>
          <a:xfrm>
            <a:off x="4968451" y="4530581"/>
            <a:ext cx="1366054" cy="1404000"/>
          </a:xfrm>
          <a:prstGeom prst="rect">
            <a:avLst/>
          </a:prstGeom>
        </p:spPr>
      </p:pic>
      <p:cxnSp>
        <p:nvCxnSpPr>
          <p:cNvPr id="52" name="直接连接符 51"/>
          <p:cNvCxnSpPr/>
          <p:nvPr/>
        </p:nvCxnSpPr>
        <p:spPr>
          <a:xfrm>
            <a:off x="1749934" y="1650158"/>
            <a:ext cx="30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>
            <a:off x="5151121" y="1021757"/>
            <a:ext cx="18002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llogeneic Vγ9Vδ2 T cell </a:t>
            </a:r>
          </a:p>
          <a:p>
            <a:pPr algn="ctr"/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+</a:t>
            </a:r>
          </a:p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MDR-TB drugs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1898173" y="1403515"/>
            <a:ext cx="26786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ling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llogeneic Vγ9Vδ2 T cell alone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下箭头 14"/>
          <p:cNvSpPr/>
          <p:nvPr/>
        </p:nvSpPr>
        <p:spPr>
          <a:xfrm>
            <a:off x="5965801" y="1985885"/>
            <a:ext cx="170876" cy="527542"/>
          </a:xfrm>
          <a:prstGeom prst="downArrow">
            <a:avLst/>
          </a:prstGeom>
          <a:solidFill>
            <a:schemeClr val="bg1"/>
          </a:solidFill>
          <a:ln>
            <a:solidFill>
              <a:srgbClr val="FF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cxnSp>
        <p:nvCxnSpPr>
          <p:cNvPr id="56" name="直接连接符 55"/>
          <p:cNvCxnSpPr/>
          <p:nvPr/>
        </p:nvCxnSpPr>
        <p:spPr>
          <a:xfrm>
            <a:off x="5965801" y="1687762"/>
            <a:ext cx="720000" cy="0"/>
          </a:xfrm>
          <a:prstGeom prst="line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9"/>
          <p:cNvSpPr txBox="1"/>
          <p:nvPr/>
        </p:nvSpPr>
        <p:spPr>
          <a:xfrm>
            <a:off x="5876193" y="1715266"/>
            <a:ext cx="6411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5~12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下箭头 22"/>
          <p:cNvSpPr/>
          <p:nvPr/>
        </p:nvSpPr>
        <p:spPr>
          <a:xfrm rot="10800000">
            <a:off x="6151660" y="2806142"/>
            <a:ext cx="177440" cy="539308"/>
          </a:xfrm>
          <a:prstGeom prst="downArrow">
            <a:avLst/>
          </a:prstGeom>
          <a:solidFill>
            <a:schemeClr val="bg1"/>
          </a:solidFill>
          <a:ln>
            <a:solidFill>
              <a:srgbClr val="03ED0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00"/>
          </a:p>
        </p:txBody>
      </p:sp>
      <p:sp>
        <p:nvSpPr>
          <p:cNvPr id="60" name="TextBox 29"/>
          <p:cNvSpPr txBox="1"/>
          <p:nvPr/>
        </p:nvSpPr>
        <p:spPr>
          <a:xfrm>
            <a:off x="6100252" y="3351383"/>
            <a:ext cx="6411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6-12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0866674"/>
              </p:ext>
            </p:extLst>
          </p:nvPr>
        </p:nvGraphicFramePr>
        <p:xfrm>
          <a:off x="1081042" y="3224808"/>
          <a:ext cx="2277447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88" name="Prism 7" r:id="rId3" imgW="4257675" imgH="3362325" progId="Prism7.Document">
                  <p:embed/>
                </p:oleObj>
              </mc:Choice>
              <mc:Fallback>
                <p:oleObj name="Prism 7" r:id="rId3" imgW="4257675" imgH="3362325" progId="Prism7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81042" y="3224808"/>
                        <a:ext cx="2277447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6592076"/>
              </p:ext>
            </p:extLst>
          </p:nvPr>
        </p:nvGraphicFramePr>
        <p:xfrm>
          <a:off x="3559336" y="3220591"/>
          <a:ext cx="2726896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89" name="Prism 7" r:id="rId5" imgW="5124450" imgH="3390900" progId="Prism7.Document">
                  <p:embed/>
                </p:oleObj>
              </mc:Choice>
              <mc:Fallback>
                <p:oleObj name="Prism 7" r:id="rId5" imgW="5124450" imgH="3390900" progId="Prism7.Document">
                  <p:embed/>
                  <p:pic>
                    <p:nvPicPr>
                      <p:cNvPr id="0" name="对象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59336" y="3220591"/>
                        <a:ext cx="2726896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3195659"/>
              </p:ext>
            </p:extLst>
          </p:nvPr>
        </p:nvGraphicFramePr>
        <p:xfrm>
          <a:off x="692696" y="5313240"/>
          <a:ext cx="2685383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90" name="Prism 7" r:id="rId7" imgW="5000625" imgH="3352800" progId="Prism7.Document">
                  <p:embed/>
                </p:oleObj>
              </mc:Choice>
              <mc:Fallback>
                <p:oleObj name="Prism 7" r:id="rId7" imgW="5000625" imgH="3352800" progId="Prism7.Document">
                  <p:embed/>
                  <p:pic>
                    <p:nvPicPr>
                      <p:cNvPr id="0" name="对象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2696" y="5313240"/>
                        <a:ext cx="2685383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2723277"/>
              </p:ext>
            </p:extLst>
          </p:nvPr>
        </p:nvGraphicFramePr>
        <p:xfrm>
          <a:off x="3623936" y="5294390"/>
          <a:ext cx="2685384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91" name="Prism 7" r:id="rId9" imgW="5000625" imgH="3352800" progId="Prism7.Document">
                  <p:embed/>
                </p:oleObj>
              </mc:Choice>
              <mc:Fallback>
                <p:oleObj name="Prism 7" r:id="rId9" imgW="5000625" imgH="3352800" progId="Prism7.Document">
                  <p:embed/>
                  <p:pic>
                    <p:nvPicPr>
                      <p:cNvPr id="0" name="对象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23936" y="5294390"/>
                        <a:ext cx="2685384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1472791" y="3008784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363968" y="5132383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472791" y="5147804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363968" y="3008784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"/>
          <p:cNvSpPr txBox="1"/>
          <p:nvPr/>
        </p:nvSpPr>
        <p:spPr>
          <a:xfrm>
            <a:off x="1806174" y="560512"/>
            <a:ext cx="314380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32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2</a:t>
            </a:r>
            <a:endParaRPr lang="zh-CN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696" y="1280592"/>
            <a:ext cx="5110793" cy="4399671"/>
          </a:xfrm>
          <a:prstGeom prst="rect">
            <a:avLst/>
          </a:prstGeom>
        </p:spPr>
      </p:pic>
      <p:sp>
        <p:nvSpPr>
          <p:cNvPr id="5" name="TextBox 1"/>
          <p:cNvSpPr txBox="1"/>
          <p:nvPr/>
        </p:nvSpPr>
        <p:spPr>
          <a:xfrm>
            <a:off x="1812547" y="344488"/>
            <a:ext cx="314380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32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3</a:t>
            </a:r>
            <a:endParaRPr lang="zh-CN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906788" y="704528"/>
            <a:ext cx="3044423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3200" b="1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en-US" altLang="zh-CN" sz="3200" b="1" dirty="0">
                <a:latin typeface="Arial" panose="020B0604020202020204" pitchFamily="34" charset="0"/>
              </a:rPr>
              <a:t>Table 1 </a:t>
            </a:r>
            <a:endParaRPr lang="zh-CN" altLang="en-US" sz="3200" b="1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396271" y="2000672"/>
          <a:ext cx="6037594" cy="282969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816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0840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0428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4320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49225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ptom 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gnose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cations 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7742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y 2008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gh, Fatigue, Fever and Night sweats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lmonary tuberculosis 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“HRZE” for about 12 months 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86365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ne 2013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gh recurrence with a small amount of hemoptysis 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erculosis recurrence 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"2HRZE/6HR" 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3030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bruary 2017 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ssive hemoptysis, cough, night sweats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erculosis recurrence 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e hemostasis and “HRZE” for about 14 months 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86365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gust 2018 </a:t>
                      </a:r>
                      <a:endParaRPr lang="zh-CN" sz="11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gh recurrence with intermittent hemoptysis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R-TB 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ogen</a:t>
                      </a:r>
                      <a:r>
                        <a:rPr lang="en-US" altLang="zh-CN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 Vγ9Vδ2 T cells immunotherapy 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478" marR="47478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4" name="矩形 3"/>
          <p:cNvSpPr/>
          <p:nvPr/>
        </p:nvSpPr>
        <p:spPr>
          <a:xfrm>
            <a:off x="404664" y="4953000"/>
            <a:ext cx="5832648" cy="6848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Note:  “HRZE” is isoniazid, rifampicin, pyrazinamide and </a:t>
            </a:r>
            <a:r>
              <a:rPr lang="en-US" altLang="zh-CN" sz="1100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ethambutol</a:t>
            </a:r>
            <a:r>
              <a:rPr lang="en-US" altLang="zh-CN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.</a:t>
            </a:r>
            <a:endParaRPr lang="zh-CN" altLang="zh-CN" sz="1100" kern="100" dirty="0">
              <a:latin typeface="Calibri" panose="020F0502020204030204" charset="0"/>
              <a:cs typeface="Times New Roman" panose="02020603050405020304" pitchFamily="18" charset="0"/>
            </a:endParaRPr>
          </a:p>
          <a:p>
            <a:pPr marL="447675" indent="-85725"/>
            <a:r>
              <a:rPr lang="en-US" altLang="zh-CN" sz="1100" dirty="0">
                <a:latin typeface="Arial" panose="020B0604020202020204" pitchFamily="34" charset="0"/>
              </a:rPr>
              <a:t>  “2HRZE/6HR” mean isoniazid, rifampicin, pyrazinamide, ethambutol once a day for 2 months. Continuation period: isoniazid and rifampicin once a day for 6 months.</a:t>
            </a:r>
            <a:endParaRPr lang="zh-CN" altLang="en-US" sz="11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87</TotalTime>
  <Words>252</Words>
  <Application>Microsoft Office PowerPoint</Application>
  <PresentationFormat>A4 纸张(210x297 毫米)</PresentationFormat>
  <Paragraphs>68</Paragraphs>
  <Slides>6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Arial</vt:lpstr>
      <vt:lpstr>Calibri</vt:lpstr>
      <vt:lpstr>Times New Roman</vt:lpstr>
      <vt:lpstr>Office 主题</vt:lpstr>
      <vt:lpstr>Prism 7</vt:lpstr>
      <vt:lpstr>Allogeneic Vγ9Vδ2 T Cell Therapy Promote Pulmonary Lesion Repairment: An Open-labelled, Single-arm, Pilot Study in MDR-TB Patient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梁 娟</cp:lastModifiedBy>
  <cp:revision>434</cp:revision>
  <dcterms:created xsi:type="dcterms:W3CDTF">2020-04-21T14:39:00Z</dcterms:created>
  <dcterms:modified xsi:type="dcterms:W3CDTF">2021-10-25T11:07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580298D2E124D1289B9849015AE915A</vt:lpwstr>
  </property>
  <property fmtid="{D5CDD505-2E9C-101B-9397-08002B2CF9AE}" pid="3" name="KSOProductBuildVer">
    <vt:lpwstr>2052-11.1.0.10938</vt:lpwstr>
  </property>
</Properties>
</file>